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6" r:id="rId2"/>
  </p:sldIdLst>
  <p:sldSz cx="6858000" cy="9144000" type="screen4x3"/>
  <p:notesSz cx="7099300" cy="1023461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8000"/>
    <a:srgbClr val="CCFF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7185" autoAdjust="0"/>
    <p:restoredTop sz="94660"/>
  </p:normalViewPr>
  <p:slideViewPr>
    <p:cSldViewPr snapToGrid="0">
      <p:cViewPr>
        <p:scale>
          <a:sx n="200" d="100"/>
          <a:sy n="200" d="100"/>
        </p:scale>
        <p:origin x="834" y="47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1F4296-DDB8-436A-88EF-B20F3C9331B3}" type="datetimeFigureOut">
              <a:rPr kumimoji="1" lang="ja-JP" altLang="en-US" smtClean="0"/>
              <a:t>2017/1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46AD4A-22B2-4F77-BCF4-6DC2DBF301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916792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1F4296-DDB8-436A-88EF-B20F3C9331B3}" type="datetimeFigureOut">
              <a:rPr kumimoji="1" lang="ja-JP" altLang="en-US" smtClean="0"/>
              <a:t>2017/1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46AD4A-22B2-4F77-BCF4-6DC2DBF301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988749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1F4296-DDB8-436A-88EF-B20F3C9331B3}" type="datetimeFigureOut">
              <a:rPr kumimoji="1" lang="ja-JP" altLang="en-US" smtClean="0"/>
              <a:t>2017/1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46AD4A-22B2-4F77-BCF4-6DC2DBF301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347294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1F4296-DDB8-436A-88EF-B20F3C9331B3}" type="datetimeFigureOut">
              <a:rPr kumimoji="1" lang="ja-JP" altLang="en-US" smtClean="0"/>
              <a:t>2017/1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46AD4A-22B2-4F77-BCF4-6DC2DBF301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012819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1F4296-DDB8-436A-88EF-B20F3C9331B3}" type="datetimeFigureOut">
              <a:rPr kumimoji="1" lang="ja-JP" altLang="en-US" smtClean="0"/>
              <a:t>2017/1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46AD4A-22B2-4F77-BCF4-6DC2DBF301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199936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1F4296-DDB8-436A-88EF-B20F3C9331B3}" type="datetimeFigureOut">
              <a:rPr kumimoji="1" lang="ja-JP" altLang="en-US" smtClean="0"/>
              <a:t>2017/11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46AD4A-22B2-4F77-BCF4-6DC2DBF301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161902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1F4296-DDB8-436A-88EF-B20F3C9331B3}" type="datetimeFigureOut">
              <a:rPr kumimoji="1" lang="ja-JP" altLang="en-US" smtClean="0"/>
              <a:t>2017/11/13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46AD4A-22B2-4F77-BCF4-6DC2DBF301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376431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1F4296-DDB8-436A-88EF-B20F3C9331B3}" type="datetimeFigureOut">
              <a:rPr kumimoji="1" lang="ja-JP" altLang="en-US" smtClean="0"/>
              <a:t>2017/11/13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46AD4A-22B2-4F77-BCF4-6DC2DBF301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285492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1F4296-DDB8-436A-88EF-B20F3C9331B3}" type="datetimeFigureOut">
              <a:rPr kumimoji="1" lang="ja-JP" altLang="en-US" smtClean="0"/>
              <a:t>2017/11/13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46AD4A-22B2-4F77-BCF4-6DC2DBF301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520086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1F4296-DDB8-436A-88EF-B20F3C9331B3}" type="datetimeFigureOut">
              <a:rPr kumimoji="1" lang="ja-JP" altLang="en-US" smtClean="0"/>
              <a:t>2017/11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46AD4A-22B2-4F77-BCF4-6DC2DBF301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636825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1F4296-DDB8-436A-88EF-B20F3C9331B3}" type="datetimeFigureOut">
              <a:rPr kumimoji="1" lang="ja-JP" altLang="en-US" smtClean="0"/>
              <a:t>2017/11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46AD4A-22B2-4F77-BCF4-6DC2DBF301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489512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1F4296-DDB8-436A-88EF-B20F3C9331B3}" type="datetimeFigureOut">
              <a:rPr kumimoji="1" lang="ja-JP" altLang="en-US" smtClean="0"/>
              <a:t>2017/1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46AD4A-22B2-4F77-BCF4-6DC2DBF301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230505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88865389"/>
              </p:ext>
            </p:extLst>
          </p:nvPr>
        </p:nvGraphicFramePr>
        <p:xfrm>
          <a:off x="1518041" y="1413549"/>
          <a:ext cx="4192033" cy="5817746"/>
        </p:xfrm>
        <a:graphic>
          <a:graphicData uri="http://schemas.openxmlformats.org/drawingml/2006/table">
            <a:tbl>
              <a:tblPr/>
              <a:tblGrid>
                <a:gridCol w="150059">
                  <a:extLst>
                    <a:ext uri="{9D8B030D-6E8A-4147-A177-3AD203B41FA5}">
                      <a16:colId xmlns:a16="http://schemas.microsoft.com/office/drawing/2014/main" xmlns="" val="3223168731"/>
                    </a:ext>
                  </a:extLst>
                </a:gridCol>
                <a:gridCol w="571379">
                  <a:extLst>
                    <a:ext uri="{9D8B030D-6E8A-4147-A177-3AD203B41FA5}">
                      <a16:colId xmlns:a16="http://schemas.microsoft.com/office/drawing/2014/main" xmlns="" val="2581309977"/>
                    </a:ext>
                  </a:extLst>
                </a:gridCol>
                <a:gridCol w="507892">
                  <a:extLst>
                    <a:ext uri="{9D8B030D-6E8A-4147-A177-3AD203B41FA5}">
                      <a16:colId xmlns:a16="http://schemas.microsoft.com/office/drawing/2014/main" xmlns="" val="3691251572"/>
                    </a:ext>
                  </a:extLst>
                </a:gridCol>
                <a:gridCol w="784924">
                  <a:extLst>
                    <a:ext uri="{9D8B030D-6E8A-4147-A177-3AD203B41FA5}">
                      <a16:colId xmlns:a16="http://schemas.microsoft.com/office/drawing/2014/main" xmlns="" val="221810172"/>
                    </a:ext>
                  </a:extLst>
                </a:gridCol>
                <a:gridCol w="792619">
                  <a:extLst>
                    <a:ext uri="{9D8B030D-6E8A-4147-A177-3AD203B41FA5}">
                      <a16:colId xmlns:a16="http://schemas.microsoft.com/office/drawing/2014/main" xmlns="" val="2857282313"/>
                    </a:ext>
                  </a:extLst>
                </a:gridCol>
                <a:gridCol w="684885">
                  <a:extLst>
                    <a:ext uri="{9D8B030D-6E8A-4147-A177-3AD203B41FA5}">
                      <a16:colId xmlns:a16="http://schemas.microsoft.com/office/drawing/2014/main" xmlns="" val="2180457233"/>
                    </a:ext>
                  </a:extLst>
                </a:gridCol>
                <a:gridCol w="577150">
                  <a:extLst>
                    <a:ext uri="{9D8B030D-6E8A-4147-A177-3AD203B41FA5}">
                      <a16:colId xmlns:a16="http://schemas.microsoft.com/office/drawing/2014/main" xmlns="" val="1965938490"/>
                    </a:ext>
                  </a:extLst>
                </a:gridCol>
                <a:gridCol w="123125">
                  <a:extLst>
                    <a:ext uri="{9D8B030D-6E8A-4147-A177-3AD203B41FA5}">
                      <a16:colId xmlns:a16="http://schemas.microsoft.com/office/drawing/2014/main" xmlns="" val="312014597"/>
                    </a:ext>
                  </a:extLst>
                </a:gridCol>
              </a:tblGrid>
              <a:tr h="224985">
                <a:tc gridSpan="4">
                  <a:txBody>
                    <a:bodyPr/>
                    <a:lstStyle/>
                    <a:p>
                      <a:pPr algn="l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Table S</a:t>
                      </a:r>
                      <a:r>
                        <a:rPr lang="en-US" altLang="ja-JP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</a:t>
                      </a:r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 List of chlorophyll metabolic genes 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85978795"/>
                  </a:ext>
                </a:extLst>
              </a:tr>
              <a:tr h="107301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502651308"/>
                  </a:ext>
                </a:extLst>
              </a:tr>
              <a:tr h="351900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Gene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ProbeID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GenBank accession no.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Closest Arabidopsis gene model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E value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549908074"/>
                  </a:ext>
                </a:extLst>
              </a:tr>
              <a:tr h="107301"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381373167"/>
                  </a:ext>
                </a:extLst>
              </a:tr>
              <a:tr h="144221"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Biosynthesis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HEMA1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PD0028_007255 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IABW01007833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AT1G58290.1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4181825892"/>
                  </a:ext>
                </a:extLst>
              </a:tr>
              <a:tr h="144221"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HEMA2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PD0028_048590 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IABW01060464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AT1G58290.1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628833463"/>
                  </a:ext>
                </a:extLst>
              </a:tr>
              <a:tr h="144221"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GSA1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PD0028_006202 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IABW01006666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AT3G48730.1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6.00E-129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948207466"/>
                  </a:ext>
                </a:extLst>
              </a:tr>
              <a:tr h="144221"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GSA2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PD0028_002590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IABW01002749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AT5G63570.1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497661188"/>
                  </a:ext>
                </a:extLst>
              </a:tr>
              <a:tr h="144221"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HEMB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PD0028_056266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IABW01072168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AT1G69740.1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.00E-53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20004196"/>
                  </a:ext>
                </a:extLst>
              </a:tr>
              <a:tr h="144221"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HEMC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PD0028_034237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IABW01040178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AT5G08280.1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4.00E-149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757547101"/>
                  </a:ext>
                </a:extLst>
              </a:tr>
              <a:tr h="144221"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HEMD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PD0028_001674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IABW01001772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AT2G26540.1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5.00E-75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6765948"/>
                  </a:ext>
                </a:extLst>
              </a:tr>
              <a:tr h="144221"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HEME1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PD0028_017323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IABW01019146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AT3G14930.1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 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35233660"/>
                  </a:ext>
                </a:extLst>
              </a:tr>
              <a:tr h="144221"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HEME2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PD0028_036810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IABW01043755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AT2G40490.1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.00E-153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235293505"/>
                  </a:ext>
                </a:extLst>
              </a:tr>
              <a:tr h="144221"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HEMF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PD0028_064113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IABW01084672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AT1G03475.1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822148826"/>
                  </a:ext>
                </a:extLst>
              </a:tr>
              <a:tr h="144221"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HEMG1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PD0028_002258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IABW01002394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AT4G01690.1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744059906"/>
                  </a:ext>
                </a:extLst>
              </a:tr>
              <a:tr h="144221"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HEMG2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PD0028_002071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IABW01002193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AT5G14220.1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4218092432"/>
                  </a:ext>
                </a:extLst>
              </a:tr>
              <a:tr h="144221"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CHLH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PD0028_022231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IABW01025117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AT5G13630.1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710173728"/>
                  </a:ext>
                </a:extLst>
              </a:tr>
              <a:tr h="144221"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CHLI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PD0028_060734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IABW01079174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AT1G78680.1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.00E-32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159483622"/>
                  </a:ext>
                </a:extLst>
              </a:tr>
              <a:tr h="144221"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CHLD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PD0028_030521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IABW01035653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AT1G08520.1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.00E-31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082848458"/>
                  </a:ext>
                </a:extLst>
              </a:tr>
              <a:tr h="144221"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CHLM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PD0028_002202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IABW01002331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AT4G25080.3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6.00E-92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171925179"/>
                  </a:ext>
                </a:extLst>
              </a:tr>
              <a:tr h="144221"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CRD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PD0028_062998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IABW01082886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AT3G56940.1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201724715"/>
                  </a:ext>
                </a:extLst>
              </a:tr>
              <a:tr h="144221"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DVR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PD0028_019641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IABW01022025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AT5G18660.1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4.00E-153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430670587"/>
                  </a:ext>
                </a:extLst>
              </a:tr>
              <a:tr h="144221"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PORA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PD0028_010915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IABW01011881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AT5G54190.1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936959388"/>
                  </a:ext>
                </a:extLst>
              </a:tr>
              <a:tr h="144221"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PORB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PD0028_002436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IABW01002585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AT4G27440.1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698629252"/>
                  </a:ext>
                </a:extLst>
              </a:tr>
              <a:tr h="144221"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PORC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PD0028_042108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IABW01051162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AT1G03630.1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357766120"/>
                  </a:ext>
                </a:extLst>
              </a:tr>
              <a:tr h="144221"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CHLG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PD0028_045721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IABW01056275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AT3G51820.1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670963"/>
                  </a:ext>
                </a:extLst>
              </a:tr>
              <a:tr h="144221"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1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794511368"/>
                  </a:ext>
                </a:extLst>
              </a:tr>
              <a:tr h="144221"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Cycle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CAO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PD0028_016990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IABW01018733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AT3G18480.1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5.00E-147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138258351"/>
                  </a:ext>
                </a:extLst>
              </a:tr>
              <a:tr h="144221"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NYC1a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PD0028_011417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IABW01012433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AT4G13250.1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.00E-149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731550593"/>
                  </a:ext>
                </a:extLst>
              </a:tr>
              <a:tr h="144221"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NYC1b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PD0028_007614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IABW01008237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AT4G13250.1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603638322"/>
                  </a:ext>
                </a:extLst>
              </a:tr>
              <a:tr h="144221"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NOL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PD0028_003707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IABW01003943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AT5G04900.1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5.00E-176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64823303"/>
                  </a:ext>
                </a:extLst>
              </a:tr>
              <a:tr h="144221"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HCAR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PD0028_003321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IABW01003531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AT1G04620.1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54438958"/>
                  </a:ext>
                </a:extLst>
              </a:tr>
              <a:tr h="144221"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1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51054326"/>
                  </a:ext>
                </a:extLst>
              </a:tr>
              <a:tr h="144221"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Degradation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PPH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PD0028_028877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IABW01033501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AT5G13800.2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353437616"/>
                  </a:ext>
                </a:extLst>
              </a:tr>
              <a:tr h="144221"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PaO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PD0028_005603 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IABW01006015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AT3G44880.1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521952630"/>
                  </a:ext>
                </a:extLst>
              </a:tr>
              <a:tr h="144221"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RCCR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PD0028_063714 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IABW01084032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AT4G37000.1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.00E-85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483227944"/>
                  </a:ext>
                </a:extLst>
              </a:tr>
              <a:tr h="144221"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SGR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PD0028_001845 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IABW01001949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AT4G22920.1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8.00E-103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474731504"/>
                  </a:ext>
                </a:extLst>
              </a:tr>
              <a:tr h="107301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587429368"/>
                  </a:ext>
                </a:extLst>
              </a:tr>
              <a:tr h="144221"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5769" marR="5769" marT="576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678008188"/>
                  </a:ext>
                </a:extLst>
              </a:tr>
            </a:tbl>
          </a:graphicData>
        </a:graphic>
      </p:graphicFrame>
      <p:sp>
        <p:nvSpPr>
          <p:cNvPr id="3" name="テキスト ボックス 2"/>
          <p:cNvSpPr txBox="1"/>
          <p:nvPr/>
        </p:nvSpPr>
        <p:spPr>
          <a:xfrm>
            <a:off x="4359348" y="8354003"/>
            <a:ext cx="431681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Additional file 3: Table S2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2801616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606</TotalTime>
  <Words>183</Words>
  <Application>Microsoft Office PowerPoint</Application>
  <PresentationFormat>On-screen Show (4:3)</PresentationFormat>
  <Paragraphs>18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テーマ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ohmiya14</dc:creator>
  <cp:lastModifiedBy>Balindan, Danica Joy</cp:lastModifiedBy>
  <cp:revision>66</cp:revision>
  <cp:lastPrinted>2017-07-03T02:06:04Z</cp:lastPrinted>
  <dcterms:created xsi:type="dcterms:W3CDTF">2015-04-13T07:25:54Z</dcterms:created>
  <dcterms:modified xsi:type="dcterms:W3CDTF">2017-11-13T05:39:41Z</dcterms:modified>
</cp:coreProperties>
</file>